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10" r:id="rId2"/>
    <p:sldId id="302" r:id="rId3"/>
    <p:sldId id="276" r:id="rId4"/>
    <p:sldId id="311" r:id="rId5"/>
    <p:sldId id="305" r:id="rId6"/>
  </p:sldIdLst>
  <p:sldSz cx="7315200" cy="100584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ueqian Cheng" initials="XC" lastIdx="2" clrIdx="0">
    <p:extLst>
      <p:ext uri="{19B8F6BF-5375-455C-9EA6-DF929625EA0E}">
        <p15:presenceInfo xmlns:p15="http://schemas.microsoft.com/office/powerpoint/2012/main" userId="S-1-5-21-3362134674-1434254870-618424018-19742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49" autoAdjust="0"/>
    <p:restoredTop sz="94660"/>
  </p:normalViewPr>
  <p:slideViewPr>
    <p:cSldViewPr snapToGrid="0">
      <p:cViewPr>
        <p:scale>
          <a:sx n="150" d="100"/>
          <a:sy n="150" d="100"/>
        </p:scale>
        <p:origin x="1488" y="-14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8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890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940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336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995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078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313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293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90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346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55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B91FC-A2C1-40FD-BEDD-A5747CA07C7E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46FCA-9499-4415-B2DD-2A0C78E36F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6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7.em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oleObject" Target="../embeddings/oleObject4.bin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6.png"/><Relationship Id="rId5" Type="http://schemas.microsoft.com/office/2007/relationships/hdphoto" Target="../media/hdphoto2.wdp"/><Relationship Id="rId15" Type="http://schemas.openxmlformats.org/officeDocument/2006/relationships/image" Target="../media/image18.emf"/><Relationship Id="rId10" Type="http://schemas.openxmlformats.org/officeDocument/2006/relationships/image" Target="../media/image15.png"/><Relationship Id="rId4" Type="http://schemas.openxmlformats.org/officeDocument/2006/relationships/image" Target="../media/image11.png"/><Relationship Id="rId9" Type="http://schemas.openxmlformats.org/officeDocument/2006/relationships/image" Target="../media/image14.png"/><Relationship Id="rId14" Type="http://schemas.openxmlformats.org/officeDocument/2006/relationships/oleObject" Target="../embeddings/oleObject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9FB1726-32D4-042A-B16F-483DAD976877}"/>
              </a:ext>
            </a:extLst>
          </p:cNvPr>
          <p:cNvSpPr txBox="1"/>
          <p:nvPr/>
        </p:nvSpPr>
        <p:spPr>
          <a:xfrm>
            <a:off x="786653" y="4698213"/>
            <a:ext cx="5307673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1" hangingPunct="1">
              <a:spcBef>
                <a:spcPct val="0"/>
              </a:spcBef>
            </a:pP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Flagrp170 protein preferentially binds to dendritic cells (DCs)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TC-conjugated Flagrp170 were incubated with 1× 10</a:t>
            </a:r>
            <a:r>
              <a:rPr lang="en-US" altLang="zh-CN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dendritic cells or B16 tumor cells in 200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μl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of PBS containing 1% BSA on ice for 20 min. Unbound protein was removed by three washes with ice cold FACS wash buffer. The cells were fixed with 1% paraformaldehyde and analyzed by flow cytometry. FITC-conjugated BSA was used as negative controls.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791954-DD20-485A-7CE4-56DAD1B79EC9}"/>
              </a:ext>
            </a:extLst>
          </p:cNvPr>
          <p:cNvSpPr txBox="1"/>
          <p:nvPr/>
        </p:nvSpPr>
        <p:spPr>
          <a:xfrm>
            <a:off x="4305717" y="976121"/>
            <a:ext cx="254608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en-US" sz="1200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A9A7B93-838E-407D-9897-1439F520AC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6306038"/>
              </p:ext>
            </p:extLst>
          </p:nvPr>
        </p:nvGraphicFramePr>
        <p:xfrm>
          <a:off x="1504166" y="2100649"/>
          <a:ext cx="3524096" cy="259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195581" imgH="3091922" progId="Prism10.Document">
                  <p:embed/>
                </p:oleObj>
              </mc:Choice>
              <mc:Fallback>
                <p:oleObj name="Prism 10" r:id="rId2" imgW="4195581" imgH="309192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B492E8A-6914-4BCA-9383-25B3F71D52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04166" y="2100649"/>
                        <a:ext cx="3524096" cy="259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468401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2E4614E-51F2-18C8-2614-70BBEB87A5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6C56C210-4CE5-8B5A-EC8D-7AC8C7E569E6}"/>
              </a:ext>
            </a:extLst>
          </p:cNvPr>
          <p:cNvSpPr txBox="1"/>
          <p:nvPr/>
        </p:nvSpPr>
        <p:spPr>
          <a:xfrm>
            <a:off x="4415405" y="683426"/>
            <a:ext cx="2213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C7E62695-2827-B6E2-5DEF-DAE1B4F3E208}"/>
              </a:ext>
            </a:extLst>
          </p:cNvPr>
          <p:cNvGrpSpPr/>
          <p:nvPr/>
        </p:nvGrpSpPr>
        <p:grpSpPr>
          <a:xfrm>
            <a:off x="1901740" y="2039815"/>
            <a:ext cx="3092292" cy="1983819"/>
            <a:chOff x="2429477" y="1430499"/>
            <a:chExt cx="2182768" cy="1612120"/>
          </a:xfrm>
        </p:grpSpPr>
        <p:pic>
          <p:nvPicPr>
            <p:cNvPr id="91" name="Picture 35">
              <a:extLst>
                <a:ext uri="{FF2B5EF4-FFF2-40B4-BE49-F238E27FC236}">
                  <a16:creationId xmlns:a16="http://schemas.microsoft.com/office/drawing/2014/main" id="{F5CB143B-8D86-12DD-E9CB-2EEE6CC3C17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22" b="15670"/>
            <a:stretch/>
          </p:blipFill>
          <p:spPr bwMode="auto">
            <a:xfrm>
              <a:off x="3851992" y="1591564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2" name="Picture 34">
              <a:extLst>
                <a:ext uri="{FF2B5EF4-FFF2-40B4-BE49-F238E27FC236}">
                  <a16:creationId xmlns:a16="http://schemas.microsoft.com/office/drawing/2014/main" id="{6BBB9C00-65F6-88C2-46CB-01AC0748A14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57" b="15670"/>
            <a:stretch/>
          </p:blipFill>
          <p:spPr bwMode="auto">
            <a:xfrm>
              <a:off x="3226049" y="1597052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3" name="Picture 33">
              <a:extLst>
                <a:ext uri="{FF2B5EF4-FFF2-40B4-BE49-F238E27FC236}">
                  <a16:creationId xmlns:a16="http://schemas.microsoft.com/office/drawing/2014/main" id="{D63AC46F-575D-66A1-C8E0-2FAAB294728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57" b="15670"/>
            <a:stretch/>
          </p:blipFill>
          <p:spPr bwMode="auto">
            <a:xfrm>
              <a:off x="2599011" y="1602824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4" name="Picture 41">
              <a:extLst>
                <a:ext uri="{FF2B5EF4-FFF2-40B4-BE49-F238E27FC236}">
                  <a16:creationId xmlns:a16="http://schemas.microsoft.com/office/drawing/2014/main" id="{B520EA5F-8165-AAD2-D31F-C49F646B1ED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78" b="15415"/>
            <a:stretch/>
          </p:blipFill>
          <p:spPr bwMode="auto">
            <a:xfrm>
              <a:off x="3840335" y="2259875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5" name="Picture 40">
              <a:extLst>
                <a:ext uri="{FF2B5EF4-FFF2-40B4-BE49-F238E27FC236}">
                  <a16:creationId xmlns:a16="http://schemas.microsoft.com/office/drawing/2014/main" id="{D1C55FF6-D3C5-2A67-3056-4CEE08DA62F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88" b="15415"/>
            <a:stretch/>
          </p:blipFill>
          <p:spPr bwMode="auto">
            <a:xfrm>
              <a:off x="3218823" y="2263980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6" name="Picture 39">
              <a:extLst>
                <a:ext uri="{FF2B5EF4-FFF2-40B4-BE49-F238E27FC236}">
                  <a16:creationId xmlns:a16="http://schemas.microsoft.com/office/drawing/2014/main" id="{3DFFC2DA-F864-7023-EF55-2B145C82C9D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 cstate="print">
              <a:biLevel thresh="7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88" b="15415"/>
            <a:stretch/>
          </p:blipFill>
          <p:spPr bwMode="auto">
            <a:xfrm>
              <a:off x="2598215" y="2263980"/>
              <a:ext cx="603504" cy="6035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7" name="TextBox 37">
              <a:extLst>
                <a:ext uri="{FF2B5EF4-FFF2-40B4-BE49-F238E27FC236}">
                  <a16:creationId xmlns:a16="http://schemas.microsoft.com/office/drawing/2014/main" id="{A702CC9A-BA34-3982-380B-9296E9E5E3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43957" y="2873342"/>
              <a:ext cx="51117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600" dirty="0">
                  <a:latin typeface="Arial" panose="020B0604020202020204" pitchFamily="34" charset="0"/>
                </a:rPr>
                <a:t>CD8</a:t>
              </a:r>
            </a:p>
          </p:txBody>
        </p:sp>
        <p:cxnSp>
          <p:nvCxnSpPr>
            <p:cNvPr id="98" name="直接箭头连接符 11">
              <a:extLst>
                <a:ext uri="{FF2B5EF4-FFF2-40B4-BE49-F238E27FC236}">
                  <a16:creationId xmlns:a16="http://schemas.microsoft.com/office/drawing/2014/main" id="{8B16E83B-B252-3B8D-4D7B-E761ED752E5E}"/>
                </a:ext>
              </a:extLst>
            </p:cNvPr>
            <p:cNvCxnSpPr>
              <a:cxnSpLocks/>
            </p:cNvCxnSpPr>
            <p:nvPr/>
          </p:nvCxnSpPr>
          <p:spPr>
            <a:xfrm>
              <a:off x="2656790" y="2902754"/>
              <a:ext cx="1764285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27">
              <a:extLst>
                <a:ext uri="{FF2B5EF4-FFF2-40B4-BE49-F238E27FC236}">
                  <a16:creationId xmlns:a16="http://schemas.microsoft.com/office/drawing/2014/main" id="{3193BBC7-3491-B539-1BFD-16D14205BA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340735" y="2512173"/>
              <a:ext cx="329496" cy="147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None/>
              </a:pP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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接箭头连接符 7">
              <a:extLst>
                <a:ext uri="{FF2B5EF4-FFF2-40B4-BE49-F238E27FC236}">
                  <a16:creationId xmlns:a16="http://schemas.microsoft.com/office/drawing/2014/main" id="{29BBF33C-1605-1A6E-5B11-3AE4D628A2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77124" y="2323088"/>
              <a:ext cx="0" cy="5254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27">
              <a:extLst>
                <a:ext uri="{FF2B5EF4-FFF2-40B4-BE49-F238E27FC236}">
                  <a16:creationId xmlns:a16="http://schemas.microsoft.com/office/drawing/2014/main" id="{6F2DA12E-BEB0-CC9C-DABA-C0BE5AA7A0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301530" y="1867494"/>
              <a:ext cx="403134" cy="147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None/>
              </a:pP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D90.1</a:t>
              </a:r>
              <a:endParaRPr lang="en-US" altLang="en-US" sz="600" dirty="0">
                <a:latin typeface="Arial" panose="020B0604020202020204" pitchFamily="34" charset="0"/>
              </a:endParaRPr>
            </a:p>
          </p:txBody>
        </p:sp>
        <p:cxnSp>
          <p:nvCxnSpPr>
            <p:cNvPr id="102" name="直接箭头连接符 7">
              <a:extLst>
                <a:ext uri="{FF2B5EF4-FFF2-40B4-BE49-F238E27FC236}">
                  <a16:creationId xmlns:a16="http://schemas.microsoft.com/office/drawing/2014/main" id="{17CC75DA-3760-1214-75C2-F2B65E1DB0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76777" y="1618098"/>
              <a:ext cx="0" cy="5254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A3E3C13F-779F-2EFF-BC01-E4A5EF102C80}"/>
                </a:ext>
              </a:extLst>
            </p:cNvPr>
            <p:cNvSpPr txBox="1"/>
            <p:nvPr/>
          </p:nvSpPr>
          <p:spPr>
            <a:xfrm>
              <a:off x="2617384" y="1622865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8%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317C0EDC-BCBA-9E47-FC32-2F7CB77A1179}"/>
                </a:ext>
              </a:extLst>
            </p:cNvPr>
            <p:cNvSpPr txBox="1"/>
            <p:nvPr/>
          </p:nvSpPr>
          <p:spPr>
            <a:xfrm>
              <a:off x="3263848" y="1625875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4%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0F03B89C-3EDF-539D-3C2E-A85AA7E0553B}"/>
                </a:ext>
              </a:extLst>
            </p:cNvPr>
            <p:cNvSpPr txBox="1"/>
            <p:nvPr/>
          </p:nvSpPr>
          <p:spPr>
            <a:xfrm>
              <a:off x="3884089" y="1622865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.0%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C5E692D4-9E74-1AA5-60A0-9D7FB6A976F0}"/>
                </a:ext>
              </a:extLst>
            </p:cNvPr>
            <p:cNvSpPr txBox="1"/>
            <p:nvPr/>
          </p:nvSpPr>
          <p:spPr>
            <a:xfrm>
              <a:off x="2592328" y="2334114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.8%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608B26E1-0C2F-9B2B-86EB-5E5A7758160C}"/>
                </a:ext>
              </a:extLst>
            </p:cNvPr>
            <p:cNvSpPr txBox="1"/>
            <p:nvPr/>
          </p:nvSpPr>
          <p:spPr>
            <a:xfrm>
              <a:off x="3272499" y="2334114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.2%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7DF8C33A-0878-7A08-58AF-5CAE1977404F}"/>
                </a:ext>
              </a:extLst>
            </p:cNvPr>
            <p:cNvSpPr txBox="1"/>
            <p:nvPr/>
          </p:nvSpPr>
          <p:spPr>
            <a:xfrm>
              <a:off x="3925881" y="2330026"/>
              <a:ext cx="555854" cy="168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3.2%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B0D4D129-2F57-8620-BD27-A74B707FFB9B}"/>
                </a:ext>
              </a:extLst>
            </p:cNvPr>
            <p:cNvSpPr txBox="1"/>
            <p:nvPr/>
          </p:nvSpPr>
          <p:spPr>
            <a:xfrm>
              <a:off x="2540253" y="1449472"/>
              <a:ext cx="7011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845CE549-375C-987D-8C1F-23CCDA034365}"/>
                </a:ext>
              </a:extLst>
            </p:cNvPr>
            <p:cNvSpPr txBox="1"/>
            <p:nvPr/>
          </p:nvSpPr>
          <p:spPr>
            <a:xfrm>
              <a:off x="3122875" y="1439666"/>
              <a:ext cx="81008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rp170-gp100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D33A4C47-4E7B-8595-6061-C27A13F9ED97}"/>
                </a:ext>
              </a:extLst>
            </p:cNvPr>
            <p:cNvSpPr txBox="1"/>
            <p:nvPr/>
          </p:nvSpPr>
          <p:spPr>
            <a:xfrm>
              <a:off x="3725714" y="1430499"/>
              <a:ext cx="88653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Flagrp170-gp100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5C82C1F3-B40D-672B-78C9-E3441915C201}"/>
              </a:ext>
            </a:extLst>
          </p:cNvPr>
          <p:cNvSpPr txBox="1"/>
          <p:nvPr/>
        </p:nvSpPr>
        <p:spPr>
          <a:xfrm>
            <a:off x="983312" y="4120856"/>
            <a:ext cx="4948811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Immunization with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lagrp170-gp100 protein complex results in enhanced T cell activation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in vivo.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mel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T cells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2 × 10</a:t>
            </a:r>
            <a:r>
              <a:rPr lang="en-US" alt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were transferred into recipient C57BL/6 mice by tail vein injection. Mice were immunized the next day with Grp170-gp100 or Flagrp170-gp100 complex. Lymph node cells were recovered 3 days later and analyzed or expansion and activation of gp100-specific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mel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s by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low cytometry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517822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27">
            <a:extLst>
              <a:ext uri="{FF2B5EF4-FFF2-40B4-BE49-F238E27FC236}">
                <a16:creationId xmlns:a16="http://schemas.microsoft.com/office/drawing/2014/main" id="{6138C431-DD15-4C2C-9D32-FA854E7A3A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1777" y="3712725"/>
            <a:ext cx="5302097" cy="7325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54864" tIns="27432" rIns="54864" bIns="27432" numCol="1" anchor="t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S3. Flagrp170 enhanced dendritic cell activation is independent of NLRC4. 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one marrow-derived dendritic cells from WT or NLRC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ice were cultured in the presence of Flagrp170 protein, followed by evaluation of IL-12p40 and IL-6 production by ELISA. ns, not significant.</a:t>
            </a:r>
            <a:endParaRPr lang="en-US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B79D76-11A1-54BB-7E0E-D17D4604D0AA}"/>
              </a:ext>
            </a:extLst>
          </p:cNvPr>
          <p:cNvSpPr txBox="1"/>
          <p:nvPr/>
        </p:nvSpPr>
        <p:spPr>
          <a:xfrm>
            <a:off x="4131592" y="567870"/>
            <a:ext cx="253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B0D5AE0-8FDF-47B7-805E-4C41C9C2A6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5009072"/>
              </p:ext>
            </p:extLst>
          </p:nvPr>
        </p:nvGraphicFramePr>
        <p:xfrm>
          <a:off x="1721427" y="1974273"/>
          <a:ext cx="2129441" cy="1824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122377" imgH="2674144" progId="Prism10.Document">
                  <p:embed/>
                </p:oleObj>
              </mc:Choice>
              <mc:Fallback>
                <p:oleObj name="Prism 10" r:id="rId2" imgW="3122377" imgH="267414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21427" y="1974273"/>
                        <a:ext cx="2129441" cy="1824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CC1018E-E186-4C2F-864C-D54E0F4377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594677"/>
              </p:ext>
            </p:extLst>
          </p:nvPr>
        </p:nvGraphicFramePr>
        <p:xfrm>
          <a:off x="3562825" y="1974273"/>
          <a:ext cx="2070981" cy="1824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37024" imgH="2674144" progId="Prism10.Document">
                  <p:embed/>
                </p:oleObj>
              </mc:Choice>
              <mc:Fallback>
                <p:oleObj name="Prism 10" r:id="rId4" imgW="3037024" imgH="267414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62825" y="1974273"/>
                        <a:ext cx="2070981" cy="1824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677415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4" descr="c2-cd8-2.tif">
            <a:extLst>
              <a:ext uri="{FF2B5EF4-FFF2-40B4-BE49-F238E27FC236}">
                <a16:creationId xmlns:a16="http://schemas.microsoft.com/office/drawing/2014/main" id="{36F62403-393F-BAC8-B711-1345195200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256743" y="2454943"/>
            <a:ext cx="843734" cy="579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6" descr="f2-cd8-2.tif">
            <a:extLst>
              <a:ext uri="{FF2B5EF4-FFF2-40B4-BE49-F238E27FC236}">
                <a16:creationId xmlns:a16="http://schemas.microsoft.com/office/drawing/2014/main" id="{53C375BC-E9F4-9DC7-A74F-7ABC4E5891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256742" y="3643219"/>
            <a:ext cx="843734" cy="579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8" descr="g3-cd8-2.tif">
            <a:extLst>
              <a:ext uri="{FF2B5EF4-FFF2-40B4-BE49-F238E27FC236}">
                <a16:creationId xmlns:a16="http://schemas.microsoft.com/office/drawing/2014/main" id="{9A049AB6-67D0-40CC-A891-3F5E6291E8D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258161" y="3048135"/>
            <a:ext cx="843734" cy="579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0">
            <a:extLst>
              <a:ext uri="{FF2B5EF4-FFF2-40B4-BE49-F238E27FC236}">
                <a16:creationId xmlns:a16="http://schemas.microsoft.com/office/drawing/2014/main" id="{BEBF6924-56F0-77A5-49CF-26824E1381EB}"/>
              </a:ext>
            </a:extLst>
          </p:cNvPr>
          <p:cNvSpPr txBox="1">
            <a:spLocks noChangeArrowheads="1"/>
          </p:cNvSpPr>
          <p:nvPr/>
        </p:nvSpPr>
        <p:spPr bwMode="auto">
          <a:xfrm rot="5400000">
            <a:off x="3948169" y="2652499"/>
            <a:ext cx="4347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600" dirty="0">
                <a:latin typeface="Arial" panose="020B0604020202020204" pitchFamily="34" charset="0"/>
              </a:rPr>
              <a:t>Control</a:t>
            </a:r>
          </a:p>
        </p:txBody>
      </p:sp>
      <p:sp>
        <p:nvSpPr>
          <p:cNvPr id="19" name="TextBox 11">
            <a:extLst>
              <a:ext uri="{FF2B5EF4-FFF2-40B4-BE49-F238E27FC236}">
                <a16:creationId xmlns:a16="http://schemas.microsoft.com/office/drawing/2014/main" id="{DB7A25E1-F6CC-1E5E-9047-3EBD0BBAEE7E}"/>
              </a:ext>
            </a:extLst>
          </p:cNvPr>
          <p:cNvSpPr txBox="1">
            <a:spLocks noChangeArrowheads="1"/>
          </p:cNvSpPr>
          <p:nvPr/>
        </p:nvSpPr>
        <p:spPr bwMode="auto">
          <a:xfrm rot="5400000">
            <a:off x="3879364" y="3217307"/>
            <a:ext cx="5934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600" dirty="0">
                <a:latin typeface="Arial" panose="020B0604020202020204" pitchFamily="34" charset="0"/>
              </a:rPr>
              <a:t>Grp170-Luc</a:t>
            </a:r>
          </a:p>
        </p:txBody>
      </p:sp>
      <p:sp>
        <p:nvSpPr>
          <p:cNvPr id="20" name="TextBox 12">
            <a:extLst>
              <a:ext uri="{FF2B5EF4-FFF2-40B4-BE49-F238E27FC236}">
                <a16:creationId xmlns:a16="http://schemas.microsoft.com/office/drawing/2014/main" id="{656DC224-E540-9CCD-E0F9-5EE481C93E5B}"/>
              </a:ext>
            </a:extLst>
          </p:cNvPr>
          <p:cNvSpPr txBox="1">
            <a:spLocks noChangeArrowheads="1"/>
          </p:cNvSpPr>
          <p:nvPr/>
        </p:nvSpPr>
        <p:spPr bwMode="auto">
          <a:xfrm rot="5400000">
            <a:off x="3823134" y="3840775"/>
            <a:ext cx="68480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600" dirty="0">
                <a:latin typeface="Arial" panose="020B0604020202020204" pitchFamily="34" charset="0"/>
              </a:rPr>
              <a:t>Flagrp170-Luc</a:t>
            </a:r>
          </a:p>
        </p:txBody>
      </p:sp>
      <p:sp>
        <p:nvSpPr>
          <p:cNvPr id="21" name="TextBox 37">
            <a:extLst>
              <a:ext uri="{FF2B5EF4-FFF2-40B4-BE49-F238E27FC236}">
                <a16:creationId xmlns:a16="http://schemas.microsoft.com/office/drawing/2014/main" id="{3F758B34-0CBB-7C43-1F37-D333BFC679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8461" y="2343381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22" name="TextBox 37">
            <a:extLst>
              <a:ext uri="{FF2B5EF4-FFF2-40B4-BE49-F238E27FC236}">
                <a16:creationId xmlns:a16="http://schemas.microsoft.com/office/drawing/2014/main" id="{0733858F-6E53-1499-4B8B-1A4146E982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6507" y="2326193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B</a:t>
            </a:r>
          </a:p>
        </p:txBody>
      </p:sp>
      <p:grpSp>
        <p:nvGrpSpPr>
          <p:cNvPr id="6" name="Group 15">
            <a:extLst>
              <a:ext uri="{FF2B5EF4-FFF2-40B4-BE49-F238E27FC236}">
                <a16:creationId xmlns:a16="http://schemas.microsoft.com/office/drawing/2014/main" id="{3B336A80-D416-9DC3-6FE8-06065AFBC6D9}"/>
              </a:ext>
            </a:extLst>
          </p:cNvPr>
          <p:cNvGrpSpPr>
            <a:grpSpLocks/>
          </p:cNvGrpSpPr>
          <p:nvPr/>
        </p:nvGrpSpPr>
        <p:grpSpPr bwMode="auto">
          <a:xfrm>
            <a:off x="4390712" y="2488536"/>
            <a:ext cx="1687510" cy="1642207"/>
            <a:chOff x="3514427" y="4491021"/>
            <a:chExt cx="1828800" cy="1941941"/>
          </a:xfrm>
        </p:grpSpPr>
        <p:pic>
          <p:nvPicPr>
            <p:cNvPr id="8" name="Picture 3">
              <a:extLst>
                <a:ext uri="{FF2B5EF4-FFF2-40B4-BE49-F238E27FC236}">
                  <a16:creationId xmlns:a16="http://schemas.microsoft.com/office/drawing/2014/main" id="{6517ED60-3F78-5416-39BF-D046F089E31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14427" y="4491021"/>
              <a:ext cx="1828800" cy="194194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" name="Group 17">
              <a:extLst>
                <a:ext uri="{FF2B5EF4-FFF2-40B4-BE49-F238E27FC236}">
                  <a16:creationId xmlns:a16="http://schemas.microsoft.com/office/drawing/2014/main" id="{CDF7656C-10A1-D9FE-2365-3CBB770DE64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92098" y="4833351"/>
              <a:ext cx="685831" cy="442854"/>
              <a:chOff x="4094964" y="5078475"/>
              <a:chExt cx="685831" cy="442854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B0FFE277-59FA-4F9D-2FD1-06E898E65EB8}"/>
                  </a:ext>
                </a:extLst>
              </p:cNvPr>
              <p:cNvCxnSpPr/>
              <p:nvPr/>
            </p:nvCxnSpPr>
            <p:spPr>
              <a:xfrm>
                <a:off x="4460106" y="5399957"/>
                <a:ext cx="32068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1D9084C4-4495-308F-6009-FA525E80265F}"/>
                  </a:ext>
                </a:extLst>
              </p:cNvPr>
              <p:cNvCxnSpPr/>
              <p:nvPr/>
            </p:nvCxnSpPr>
            <p:spPr>
              <a:xfrm>
                <a:off x="4094964" y="5257094"/>
                <a:ext cx="6858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20">
                <a:extLst>
                  <a:ext uri="{FF2B5EF4-FFF2-40B4-BE49-F238E27FC236}">
                    <a16:creationId xmlns:a16="http://schemas.microsoft.com/office/drawing/2014/main" id="{2CD11856-59E0-4AA8-D594-EB340B1F84E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08810" y="5230168"/>
                <a:ext cx="253982" cy="2911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3" name="TextBox 21">
                <a:extLst>
                  <a:ext uri="{FF2B5EF4-FFF2-40B4-BE49-F238E27FC236}">
                    <a16:creationId xmlns:a16="http://schemas.microsoft.com/office/drawing/2014/main" id="{52239804-0692-A892-2AE5-8CE407770AE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64795" y="5078475"/>
                <a:ext cx="307835" cy="2911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254F5D92-114C-2705-24B9-D6CA436AE4B3}"/>
              </a:ext>
            </a:extLst>
          </p:cNvPr>
          <p:cNvSpPr txBox="1"/>
          <p:nvPr/>
        </p:nvSpPr>
        <p:spPr>
          <a:xfrm>
            <a:off x="905413" y="5874604"/>
            <a:ext cx="5465242" cy="1954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ct val="0"/>
              </a:spcBef>
            </a:pP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Flagrp170-based chaperone complex vaccine induces improved tumor inhibition associated with increased tumor infiltration by activated CD8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Mice with established luciferase-expressing B16 tumors were treated with chaperone-luciferase complex every three days for three immunizations beginning on day 5 after tumor inoculation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Tumor sections were subjected to immunohistochemistry staining using anti-CD8 antibodies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Mice bearing metastases of B16 tumor received chaperone-gp100 complex vaccines, followed by flow cytometry analysis for IFN-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-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xpressing CD8</a:t>
            </a:r>
            <a:r>
              <a:rPr lang="en-US" altLang="zh-CN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T cells infiltrating the lung metastase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VBN202 mice established with MMC mammary tumors received immunization with chaperone-Her2/neu protein complexes. Tumor tissues were analyzed for transcriptional change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oxp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*, P &lt; 0.05, **, P &lt; 0.01.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AD108541-7CBE-D651-FC76-01C18655B25C}"/>
              </a:ext>
            </a:extLst>
          </p:cNvPr>
          <p:cNvGrpSpPr/>
          <p:nvPr/>
        </p:nvGrpSpPr>
        <p:grpSpPr>
          <a:xfrm>
            <a:off x="1122523" y="4517223"/>
            <a:ext cx="2915064" cy="1254351"/>
            <a:chOff x="5206086" y="1768456"/>
            <a:chExt cx="1922813" cy="804265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51EE9823-4030-762F-AB74-6F642E308CE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biLevel thresh="75000"/>
            </a:blip>
            <a:stretch>
              <a:fillRect/>
            </a:stretch>
          </p:blipFill>
          <p:spPr>
            <a:xfrm>
              <a:off x="5319016" y="1851838"/>
              <a:ext cx="603504" cy="605747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296E911B-E4A4-6301-82BE-06F5E492DB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biLevel thresh="75000"/>
            </a:blip>
            <a:stretch>
              <a:fillRect/>
            </a:stretch>
          </p:blipFill>
          <p:spPr>
            <a:xfrm>
              <a:off x="5917834" y="1847154"/>
              <a:ext cx="603504" cy="60574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2FCA30B4-953B-ACC1-1467-947CD27293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biLevel thresh="75000"/>
            </a:blip>
            <a:stretch>
              <a:fillRect/>
            </a:stretch>
          </p:blipFill>
          <p:spPr>
            <a:xfrm>
              <a:off x="6525395" y="1853933"/>
              <a:ext cx="603504" cy="605747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3D80D45-3D65-D0C3-3633-2E39A5FE4CE6}"/>
                </a:ext>
              </a:extLst>
            </p:cNvPr>
            <p:cNvSpPr txBox="1"/>
            <p:nvPr/>
          </p:nvSpPr>
          <p:spPr>
            <a:xfrm>
              <a:off x="5442236" y="1776411"/>
              <a:ext cx="286756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94D8E3B-AD41-B05C-51B6-22AFE398DDC9}"/>
                </a:ext>
              </a:extLst>
            </p:cNvPr>
            <p:cNvSpPr txBox="1"/>
            <p:nvPr/>
          </p:nvSpPr>
          <p:spPr>
            <a:xfrm>
              <a:off x="6035765" y="1772700"/>
              <a:ext cx="292044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Grp17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3C3AD16-475B-F159-2C1A-332ABE608F17}"/>
                </a:ext>
              </a:extLst>
            </p:cNvPr>
            <p:cNvSpPr txBox="1"/>
            <p:nvPr/>
          </p:nvSpPr>
          <p:spPr>
            <a:xfrm>
              <a:off x="6617103" y="1768456"/>
              <a:ext cx="352313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Flagrp17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11D010E-B114-9221-886B-D4FDF3842ED3}"/>
                </a:ext>
              </a:extLst>
            </p:cNvPr>
            <p:cNvSpPr txBox="1"/>
            <p:nvPr/>
          </p:nvSpPr>
          <p:spPr>
            <a:xfrm>
              <a:off x="5613642" y="1995475"/>
              <a:ext cx="238118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8%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64C3316-E8B4-8A47-AEBC-85124C0C047F}"/>
                </a:ext>
              </a:extLst>
            </p:cNvPr>
            <p:cNvSpPr txBox="1"/>
            <p:nvPr/>
          </p:nvSpPr>
          <p:spPr>
            <a:xfrm>
              <a:off x="6210400" y="1988723"/>
              <a:ext cx="266667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.4%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FEBBA8E-09E4-CB80-AA22-1DD09F33295F}"/>
                </a:ext>
              </a:extLst>
            </p:cNvPr>
            <p:cNvSpPr txBox="1"/>
            <p:nvPr/>
          </p:nvSpPr>
          <p:spPr>
            <a:xfrm>
              <a:off x="6824040" y="1996385"/>
              <a:ext cx="266667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8.4%</a:t>
              </a: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1879CB72-C51D-010F-F593-18591C276329}"/>
                </a:ext>
              </a:extLst>
            </p:cNvPr>
            <p:cNvCxnSpPr/>
            <p:nvPr/>
          </p:nvCxnSpPr>
          <p:spPr>
            <a:xfrm>
              <a:off x="5459841" y="2483776"/>
              <a:ext cx="15544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6DE4BDC-3412-2C1B-0F19-4DE478711BEC}"/>
                </a:ext>
              </a:extLst>
            </p:cNvPr>
            <p:cNvSpPr txBox="1"/>
            <p:nvPr/>
          </p:nvSpPr>
          <p:spPr>
            <a:xfrm>
              <a:off x="6082555" y="2469633"/>
              <a:ext cx="224373" cy="103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96F83D70-45DD-28D6-2519-763340EFE5D0}"/>
                </a:ext>
              </a:extLst>
            </p:cNvPr>
            <p:cNvCxnSpPr/>
            <p:nvPr/>
          </p:nvCxnSpPr>
          <p:spPr>
            <a:xfrm flipV="1">
              <a:off x="5310348" y="1910567"/>
              <a:ext cx="0" cy="4572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CD5DA1B-CCD2-0DD4-0C72-7D82AAD6BFF5}"/>
                </a:ext>
              </a:extLst>
            </p:cNvPr>
            <p:cNvSpPr txBox="1"/>
            <p:nvPr/>
          </p:nvSpPr>
          <p:spPr>
            <a:xfrm rot="16200000">
              <a:off x="5164886" y="2113719"/>
              <a:ext cx="204207" cy="1218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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7">
            <a:extLst>
              <a:ext uri="{FF2B5EF4-FFF2-40B4-BE49-F238E27FC236}">
                <a16:creationId xmlns:a16="http://schemas.microsoft.com/office/drawing/2014/main" id="{ABCA4C19-8275-411D-99CC-E300A9F387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4451" y="4370413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9560847-207F-34B7-274D-2C9F5E234C88}"/>
              </a:ext>
            </a:extLst>
          </p:cNvPr>
          <p:cNvSpPr txBox="1"/>
          <p:nvPr/>
        </p:nvSpPr>
        <p:spPr>
          <a:xfrm>
            <a:off x="4333328" y="798982"/>
            <a:ext cx="253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099F20E-B5CF-42DA-BCFE-8789577CC1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181770"/>
              </p:ext>
            </p:extLst>
          </p:nvPr>
        </p:nvGraphicFramePr>
        <p:xfrm>
          <a:off x="810553" y="2583110"/>
          <a:ext cx="2420901" cy="1648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956451" imgH="2693952" progId="Prism10.Document">
                  <p:embed/>
                </p:oleObj>
              </mc:Choice>
              <mc:Fallback>
                <p:oleObj name="Prism 10" r:id="rId12" imgW="3956451" imgH="269395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10553" y="2583110"/>
                        <a:ext cx="2420901" cy="1648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B0146D9-C6B8-23C7-05DF-292E87A050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3429018"/>
              </p:ext>
            </p:extLst>
          </p:nvPr>
        </p:nvGraphicFramePr>
        <p:xfrm>
          <a:off x="4531661" y="4370412"/>
          <a:ext cx="1208311" cy="16379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410388" imgH="3274881" progId="Prism9.Document">
                  <p:embed/>
                </p:oleObj>
              </mc:Choice>
              <mc:Fallback>
                <p:oleObj name="Prism 9" r:id="rId14" imgW="2410388" imgH="3274881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49A9C83-1614-CB56-5BE1-A95AEFE464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531661" y="4370412"/>
                        <a:ext cx="1208311" cy="16379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7">
            <a:extLst>
              <a:ext uri="{FF2B5EF4-FFF2-40B4-BE49-F238E27FC236}">
                <a16:creationId xmlns:a16="http://schemas.microsoft.com/office/drawing/2014/main" id="{C70DD9C1-18B7-C16A-4A3E-77A92F2CAD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6524" y="4350228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531071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B8453D-2EE3-40E2-A9C7-C31FC88144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85DF4365-C70E-635D-9FF0-30A8C2415B70}"/>
              </a:ext>
            </a:extLst>
          </p:cNvPr>
          <p:cNvGrpSpPr/>
          <p:nvPr/>
        </p:nvGrpSpPr>
        <p:grpSpPr>
          <a:xfrm>
            <a:off x="1153918" y="3227106"/>
            <a:ext cx="3780909" cy="1600917"/>
            <a:chOff x="601152" y="791916"/>
            <a:chExt cx="2491019" cy="135369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64CE233-EDAF-0982-AB7F-14026199EC8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/>
            <a:srcRect l="-77" t="11998" r="15291"/>
            <a:stretch/>
          </p:blipFill>
          <p:spPr>
            <a:xfrm>
              <a:off x="719454" y="1209834"/>
              <a:ext cx="731520" cy="73152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DB40CFE-DBDA-B9D9-D634-7EC67F9D39D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776" t="32091" r="10693"/>
            <a:stretch/>
          </p:blipFill>
          <p:spPr>
            <a:xfrm>
              <a:off x="1514192" y="1222639"/>
              <a:ext cx="731520" cy="73152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61C9A58-9434-721D-48B1-444CA8AB3A0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l="-660" t="15781" r="6537"/>
            <a:stretch/>
          </p:blipFill>
          <p:spPr>
            <a:xfrm>
              <a:off x="2360651" y="1221984"/>
              <a:ext cx="731520" cy="731520"/>
            </a:xfrm>
            <a:prstGeom prst="rect">
              <a:avLst/>
            </a:prstGeom>
          </p:spPr>
        </p:pic>
        <p:cxnSp>
          <p:nvCxnSpPr>
            <p:cNvPr id="19" name="直接箭头连接符 5">
              <a:extLst>
                <a:ext uri="{FF2B5EF4-FFF2-40B4-BE49-F238E27FC236}">
                  <a16:creationId xmlns:a16="http://schemas.microsoft.com/office/drawing/2014/main" id="{03B9A3AA-1ADF-64F5-F29B-98AF4B84C9F6}"/>
                </a:ext>
              </a:extLst>
            </p:cNvPr>
            <p:cNvCxnSpPr>
              <a:cxnSpLocks/>
            </p:cNvCxnSpPr>
            <p:nvPr/>
          </p:nvCxnSpPr>
          <p:spPr>
            <a:xfrm>
              <a:off x="719454" y="1990183"/>
              <a:ext cx="6400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9">
              <a:extLst>
                <a:ext uri="{FF2B5EF4-FFF2-40B4-BE49-F238E27FC236}">
                  <a16:creationId xmlns:a16="http://schemas.microsoft.com/office/drawing/2014/main" id="{ECDB9130-EE41-68BD-5CDD-1A201B7F6F5B}"/>
                </a:ext>
              </a:extLst>
            </p:cNvPr>
            <p:cNvSpPr txBox="1"/>
            <p:nvPr/>
          </p:nvSpPr>
          <p:spPr>
            <a:xfrm>
              <a:off x="617466" y="1977227"/>
              <a:ext cx="779023" cy="156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D86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箭头连接符 5">
              <a:extLst>
                <a:ext uri="{FF2B5EF4-FFF2-40B4-BE49-F238E27FC236}">
                  <a16:creationId xmlns:a16="http://schemas.microsoft.com/office/drawing/2014/main" id="{BFB4F8D1-4104-281D-A099-F884EB18A7A7}"/>
                </a:ext>
              </a:extLst>
            </p:cNvPr>
            <p:cNvCxnSpPr>
              <a:cxnSpLocks/>
            </p:cNvCxnSpPr>
            <p:nvPr/>
          </p:nvCxnSpPr>
          <p:spPr>
            <a:xfrm>
              <a:off x="1541005" y="2000711"/>
              <a:ext cx="6400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9">
              <a:extLst>
                <a:ext uri="{FF2B5EF4-FFF2-40B4-BE49-F238E27FC236}">
                  <a16:creationId xmlns:a16="http://schemas.microsoft.com/office/drawing/2014/main" id="{58A330DF-11BC-4FB1-1158-A49F831D574D}"/>
                </a:ext>
              </a:extLst>
            </p:cNvPr>
            <p:cNvSpPr txBox="1"/>
            <p:nvPr/>
          </p:nvSpPr>
          <p:spPr>
            <a:xfrm>
              <a:off x="1405786" y="1984284"/>
              <a:ext cx="779023" cy="156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D40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箭头连接符 5">
              <a:extLst>
                <a:ext uri="{FF2B5EF4-FFF2-40B4-BE49-F238E27FC236}">
                  <a16:creationId xmlns:a16="http://schemas.microsoft.com/office/drawing/2014/main" id="{E7EFAD33-A6B1-0873-F52F-7EC7831B8D8B}"/>
                </a:ext>
              </a:extLst>
            </p:cNvPr>
            <p:cNvCxnSpPr>
              <a:cxnSpLocks/>
            </p:cNvCxnSpPr>
            <p:nvPr/>
          </p:nvCxnSpPr>
          <p:spPr>
            <a:xfrm>
              <a:off x="2415230" y="2000711"/>
              <a:ext cx="6400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9">
              <a:extLst>
                <a:ext uri="{FF2B5EF4-FFF2-40B4-BE49-F238E27FC236}">
                  <a16:creationId xmlns:a16="http://schemas.microsoft.com/office/drawing/2014/main" id="{0559276D-6290-404C-B059-CC6BA16AE854}"/>
                </a:ext>
              </a:extLst>
            </p:cNvPr>
            <p:cNvSpPr txBox="1"/>
            <p:nvPr/>
          </p:nvSpPr>
          <p:spPr>
            <a:xfrm>
              <a:off x="2285047" y="1989461"/>
              <a:ext cx="779023" cy="156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MHCII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F1B1617-7800-C575-88B4-DDDDB1AC6B6F}"/>
                </a:ext>
              </a:extLst>
            </p:cNvPr>
            <p:cNvSpPr txBox="1">
              <a:spLocks noChangeAspect="1"/>
            </p:cNvSpPr>
            <p:nvPr/>
          </p:nvSpPr>
          <p:spPr>
            <a:xfrm rot="16200000">
              <a:off x="196456" y="1541173"/>
              <a:ext cx="931058" cy="121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</a:t>
              </a:r>
              <a:r>
                <a:rPr lang="en-US" sz="600" baseline="300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 </a:t>
              </a:r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r>
                <a:rPr lang="en-US" altLang="zh-CN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4CD780B-8932-B763-A129-0B203CE0FEB4}"/>
                </a:ext>
              </a:extLst>
            </p:cNvPr>
            <p:cNvSpPr txBox="1"/>
            <p:nvPr/>
          </p:nvSpPr>
          <p:spPr>
            <a:xfrm>
              <a:off x="872421" y="1230921"/>
              <a:ext cx="624874" cy="27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95" dirty="0">
                  <a:latin typeface="Arial" panose="020B0604020202020204" pitchFamily="34" charset="0"/>
                  <a:cs typeface="Arial" panose="020B0604020202020204" pitchFamily="34" charset="0"/>
                </a:rPr>
                <a:t>37.7%, MFI 371</a:t>
              </a:r>
            </a:p>
            <a:p>
              <a:r>
                <a:rPr lang="en-US" sz="495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.9%, MFI 339</a:t>
              </a:r>
            </a:p>
            <a:p>
              <a:r>
                <a:rPr lang="en-US" sz="49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5.4%, MFI 2527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4985BE2-2448-EA79-8E02-F4F9E41A124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779726" y="1220706"/>
              <a:ext cx="676604" cy="27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95" dirty="0">
                  <a:latin typeface="Arial" panose="020B0604020202020204" pitchFamily="34" charset="0"/>
                  <a:cs typeface="Arial" panose="020B0604020202020204" pitchFamily="34" charset="0"/>
                </a:rPr>
                <a:t>15.7%, MFI 6.95</a:t>
              </a:r>
            </a:p>
            <a:p>
              <a:r>
                <a:rPr lang="en-US" sz="495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.7%, MFI 3.99</a:t>
              </a:r>
            </a:p>
            <a:p>
              <a:r>
                <a:rPr lang="en-US" sz="49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.2%, MFI 13.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66EEC64-217F-8BA8-A1DB-28E4ED6D7CE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2412830" y="1201980"/>
              <a:ext cx="678338" cy="2713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95" dirty="0">
                  <a:latin typeface="Arial" panose="020B0604020202020204" pitchFamily="34" charset="0"/>
                  <a:cs typeface="Arial" panose="020B0604020202020204" pitchFamily="34" charset="0"/>
                </a:rPr>
                <a:t>98.3%, MFI 421</a:t>
              </a:r>
            </a:p>
            <a:p>
              <a:r>
                <a:rPr lang="en-US" sz="495" dirty="0">
                  <a:solidFill>
                    <a:srgbClr val="0000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6.5%, MFI 398</a:t>
              </a:r>
            </a:p>
            <a:p>
              <a:r>
                <a:rPr lang="en-US" sz="49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%, MFI 3234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7B81BAF-F3F5-31B2-9D9B-8870A4357F51}"/>
                </a:ext>
              </a:extLst>
            </p:cNvPr>
            <p:cNvGrpSpPr/>
            <p:nvPr/>
          </p:nvGrpSpPr>
          <p:grpSpPr>
            <a:xfrm>
              <a:off x="699125" y="791916"/>
              <a:ext cx="1041197" cy="368772"/>
              <a:chOff x="715464" y="807963"/>
              <a:chExt cx="1041197" cy="368772"/>
            </a:xfrm>
          </p:grpSpPr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DE9602B7-7194-67C9-6DC0-77A01924BC23}"/>
                  </a:ext>
                </a:extLst>
              </p:cNvPr>
              <p:cNvCxnSpPr/>
              <p:nvPr/>
            </p:nvCxnSpPr>
            <p:spPr>
              <a:xfrm>
                <a:off x="715464" y="877261"/>
                <a:ext cx="304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F45BA186-5CF0-F150-D3F5-4DE652B131C3}"/>
                  </a:ext>
                </a:extLst>
              </p:cNvPr>
              <p:cNvCxnSpPr/>
              <p:nvPr/>
            </p:nvCxnSpPr>
            <p:spPr>
              <a:xfrm>
                <a:off x="715464" y="985396"/>
                <a:ext cx="304800" cy="0"/>
              </a:xfrm>
              <a:prstGeom prst="line">
                <a:avLst/>
              </a:prstGeom>
              <a:ln>
                <a:solidFill>
                  <a:srgbClr val="3939FF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54669871-70CE-1340-FA04-8B7126D7108B}"/>
                  </a:ext>
                </a:extLst>
              </p:cNvPr>
              <p:cNvCxnSpPr/>
              <p:nvPr/>
            </p:nvCxnSpPr>
            <p:spPr>
              <a:xfrm>
                <a:off x="715464" y="1088156"/>
                <a:ext cx="304800" cy="0"/>
              </a:xfrm>
              <a:prstGeom prst="line">
                <a:avLst/>
              </a:prstGeom>
              <a:ln>
                <a:solidFill>
                  <a:srgbClr val="FF4F4F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E9349A3F-7D9F-1150-DF4D-E5ED3F910E39}"/>
                  </a:ext>
                </a:extLst>
              </p:cNvPr>
              <p:cNvSpPr txBox="1"/>
              <p:nvPr/>
            </p:nvSpPr>
            <p:spPr>
              <a:xfrm>
                <a:off x="989896" y="807963"/>
                <a:ext cx="541579" cy="15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1BA6D483-E404-74E2-DD0D-F04DC359F81A}"/>
                  </a:ext>
                </a:extLst>
              </p:cNvPr>
              <p:cNvSpPr txBox="1"/>
              <p:nvPr/>
            </p:nvSpPr>
            <p:spPr>
              <a:xfrm>
                <a:off x="982411" y="916673"/>
                <a:ext cx="774250" cy="15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Grp170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DEDB49A-8B38-9662-AE67-9C450AFCF39B}"/>
                  </a:ext>
                </a:extLst>
              </p:cNvPr>
              <p:cNvSpPr txBox="1"/>
              <p:nvPr/>
            </p:nvSpPr>
            <p:spPr>
              <a:xfrm>
                <a:off x="986151" y="1020586"/>
                <a:ext cx="591385" cy="15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lagrp170</a:t>
                </a:r>
              </a:p>
            </p:txBody>
          </p:sp>
        </p:grp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2F8DB775-29CE-1083-CAC4-5EBFA38E6620}"/>
              </a:ext>
            </a:extLst>
          </p:cNvPr>
          <p:cNvSpPr txBox="1"/>
          <p:nvPr/>
        </p:nvSpPr>
        <p:spPr>
          <a:xfrm>
            <a:off x="934894" y="4765366"/>
            <a:ext cx="472187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5. Inoculation of Flagrp170 protein molecule induces enhanced activation of CD8</a:t>
            </a:r>
            <a:r>
              <a:rPr lang="en-US" altLang="zh-CN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dendritic cell (DCs) </a:t>
            </a:r>
            <a:r>
              <a:rPr lang="en-US" altLang="zh-CN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in vivo.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Recombinant Flagrp170 or Grp170 protein was intradermally injected to the </a:t>
            </a:r>
            <a:r>
              <a:rPr lang="zh-CN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bdominal wall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After 16 h, lymph nodes near the injection site were collected for flow cytometry analysis of CD8</a:t>
            </a:r>
            <a:r>
              <a:rPr lang="en-US" altLang="zh-CN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DCs. The percentage of cells with positive staining for CD86, CD40 or MHC II and mean fluorescence intensity (MFI) are shown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7294B1-8037-90F6-9C43-F76D6584BF10}"/>
              </a:ext>
            </a:extLst>
          </p:cNvPr>
          <p:cNvSpPr txBox="1"/>
          <p:nvPr/>
        </p:nvSpPr>
        <p:spPr>
          <a:xfrm>
            <a:off x="4131592" y="567870"/>
            <a:ext cx="253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25" name="TextBox 37">
            <a:extLst>
              <a:ext uri="{FF2B5EF4-FFF2-40B4-BE49-F238E27FC236}">
                <a16:creationId xmlns:a16="http://schemas.microsoft.com/office/drawing/2014/main" id="{182CB3AF-1523-4D9D-BD4D-974B4C9A2E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257" y="2822593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34172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02</TotalTime>
  <Words>526</Words>
  <Application>Microsoft Office PowerPoint</Application>
  <PresentationFormat>Custom</PresentationFormat>
  <Paragraphs>56</Paragraphs>
  <Slides>5</Slides>
  <Notes>0</Notes>
  <HiddenSlides>1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eng Liu</dc:creator>
  <cp:lastModifiedBy>MDPI</cp:lastModifiedBy>
  <cp:revision>280</cp:revision>
  <cp:lastPrinted>2025-09-15T15:23:24Z</cp:lastPrinted>
  <dcterms:created xsi:type="dcterms:W3CDTF">2020-11-23T20:38:47Z</dcterms:created>
  <dcterms:modified xsi:type="dcterms:W3CDTF">2025-10-25T10:02:05Z</dcterms:modified>
</cp:coreProperties>
</file>